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  <p:sldId id="260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5" d="100"/>
          <a:sy n="105" d="100"/>
        </p:scale>
        <p:origin x="798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CD95360-0164-6B24-F9B5-40FA12D3318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8DAF12E-567E-C34D-AE89-C577D025683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A3AD54A-E626-BBC2-2B40-B8ECE191BA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2F3A50-2CF0-4822-A8F0-0BF3F5B445F4}" type="datetimeFigureOut">
              <a:rPr lang="en-US" smtClean="0"/>
              <a:t>10/13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09B0041-63AA-11AB-17C8-BE578FCF38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3E8C16B-AD69-20B4-C346-7F83F2CF63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58A950-6A7B-41E9-AF21-F04399CAF1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73235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3870981-3EEC-1CA9-6733-B273066042D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B04CBDF-8F84-3CB5-F830-8F5345A074C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5FFC068-9D95-167C-6351-9BDE9CC5D9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2F3A50-2CF0-4822-A8F0-0BF3F5B445F4}" type="datetimeFigureOut">
              <a:rPr lang="en-US" smtClean="0"/>
              <a:t>10/13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92DE589-6D97-31D3-8831-57116D7729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2007F39-470E-0FE1-D0F4-DC899F19D9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58A950-6A7B-41E9-AF21-F04399CAF1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48954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3C8CF7E-C69B-ED44-30EF-A7BF7722F3F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4E10790-ABCD-CB45-8CC7-7DBA676B41B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F1559C3-227C-A46C-F14A-9B31C0C834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2F3A50-2CF0-4822-A8F0-0BF3F5B445F4}" type="datetimeFigureOut">
              <a:rPr lang="en-US" smtClean="0"/>
              <a:t>10/13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92F1E45-E7F8-DE3A-5363-4BF300DCF5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8C16201-12A1-D3D2-BAD7-52AFA7450A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58A950-6A7B-41E9-AF21-F04399CAF1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23572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34FDE24-0585-7967-7EBD-8170929FE97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766B3BF-C6C0-6C09-5F10-61F946CECE4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5203F1E-0E56-26E5-AE3E-E3DF5C01BA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2F3A50-2CF0-4822-A8F0-0BF3F5B445F4}" type="datetimeFigureOut">
              <a:rPr lang="en-US" smtClean="0"/>
              <a:t>10/13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8AA53DB-B1C3-9CFA-575F-408DE7B2A1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C366283-004E-6FC6-BDF6-94ECF373C5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58A950-6A7B-41E9-AF21-F04399CAF1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63994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FE0CA70-5C0A-E482-C87B-F5B163D60F2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A193A84-BBF5-31B1-659B-9C53CCF46F4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E3571DF-CCB3-9F40-CA98-913332E43D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2F3A50-2CF0-4822-A8F0-0BF3F5B445F4}" type="datetimeFigureOut">
              <a:rPr lang="en-US" smtClean="0"/>
              <a:t>10/13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8F9FC64-BA9F-4078-6747-FEAC7AE7AF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E6BD120-9CF0-99E2-C157-2540D31C85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58A950-6A7B-41E9-AF21-F04399CAF1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91044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D2B086D-3D43-BC10-5AE2-57D1DCBCB0A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1D6DB7A-6A24-4C86-5D17-C50609C672F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8AD0CED-E5F9-FBDC-3E67-3DB6B8D9303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5C26B61-8EA6-9C48-CE88-58812CE332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2F3A50-2CF0-4822-A8F0-0BF3F5B445F4}" type="datetimeFigureOut">
              <a:rPr lang="en-US" smtClean="0"/>
              <a:t>10/13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F446E69-BBD9-CBBE-8ED1-6F122F0CF8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6D03872-0FF8-8EB5-F17A-CC1A38B2B1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58A950-6A7B-41E9-AF21-F04399CAF1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26439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DD1AB49-084D-A0B5-2D27-3FB949B0E53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86B29C3-89E7-2F8B-91E1-67B51EDABBB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A53240E-F8DA-DA35-0634-2781B002A47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87F0335-3A1F-8C0D-22CA-7597791C339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F8CDBDC-9C55-538A-C7CE-877E2AD1A36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A897612-C9DC-9814-E20F-B36F67CA82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2F3A50-2CF0-4822-A8F0-0BF3F5B445F4}" type="datetimeFigureOut">
              <a:rPr lang="en-US" smtClean="0"/>
              <a:t>10/13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5DCA55B-AA00-5937-3F09-10E06335D2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5A5A787-40D4-155A-5297-9B864CD781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58A950-6A7B-41E9-AF21-F04399CAF1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81643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577BE09-8463-75A7-7276-CBEFAA1F71D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3D28E81-43C5-442A-5277-3F8A6C1928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2F3A50-2CF0-4822-A8F0-0BF3F5B445F4}" type="datetimeFigureOut">
              <a:rPr lang="en-US" smtClean="0"/>
              <a:t>10/13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9632026-5279-7C2F-5E50-0AF3ABF8AD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9E1F889-54E5-CC5D-17C8-022427B24E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58A950-6A7B-41E9-AF21-F04399CAF1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11020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AD8B88A-3D39-2AD5-0DE3-3AE9101CFA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2F3A50-2CF0-4822-A8F0-0BF3F5B445F4}" type="datetimeFigureOut">
              <a:rPr lang="en-US" smtClean="0"/>
              <a:t>10/13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081304E-C799-12DE-D169-F27998093C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CA7708A-3916-25A6-E81D-72DB2F88BF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58A950-6A7B-41E9-AF21-F04399CAF1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69657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B0BC6F5-7528-3159-7656-0177580F55C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7E58FDB-B499-0EFC-1315-D831CB28FCE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705536A-FEFD-05D6-B4B1-A2519393838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106EA19-7529-48AB-3E0E-D12B572FEE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2F3A50-2CF0-4822-A8F0-0BF3F5B445F4}" type="datetimeFigureOut">
              <a:rPr lang="en-US" smtClean="0"/>
              <a:t>10/13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251FD52-88BA-FA13-7EC8-E7277D2F89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9F9FCEF-A914-0A8D-7EAF-AD374030E3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58A950-6A7B-41E9-AF21-F04399CAF1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39339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56253E0-908B-C967-3A0B-342821A37DA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2DA31D3B-D8C7-6148-EA26-63B856573D8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6AE7A43-E564-C6ED-EA31-F3EB4EF926E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C455AE3-4965-F30F-1058-58119CA2EC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2F3A50-2CF0-4822-A8F0-0BF3F5B445F4}" type="datetimeFigureOut">
              <a:rPr lang="en-US" smtClean="0"/>
              <a:t>10/13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CC5788E-B587-0BF5-A50E-70D6CD10E1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BBC9B5C-2441-1013-712B-85F4703E61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58A950-6A7B-41E9-AF21-F04399CAF1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35333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234300B-EA45-F769-ECC6-676FD5DEA61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47EFEED-B1E8-4948-A55D-95947273FAE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0EF3E88-0704-350F-D68A-D51A9A0BA06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2F3A50-2CF0-4822-A8F0-0BF3F5B445F4}" type="datetimeFigureOut">
              <a:rPr lang="en-US" smtClean="0"/>
              <a:t>10/13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8FE371F-4088-3913-8DC2-31C492F5C94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05C0B39-F6D4-11E8-6E65-2B972260139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58A950-6A7B-41E9-AF21-F04399CAF1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78053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9206EE68-961C-8ABC-81C4-6E163CC23A0E}"/>
              </a:ext>
            </a:extLst>
          </p:cNvPr>
          <p:cNvSpPr txBox="1"/>
          <p:nvPr/>
        </p:nvSpPr>
        <p:spPr>
          <a:xfrm>
            <a:off x="4453128" y="146304"/>
            <a:ext cx="43616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Proximal colon cancer samples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F1A83028-F8F7-C22E-2A45-69AC83DE5F0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22826" y="1212980"/>
            <a:ext cx="3745710" cy="4142803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337870C3-2D5C-8727-EB27-ED02F05FDA65}"/>
              </a:ext>
            </a:extLst>
          </p:cNvPr>
          <p:cNvSpPr txBox="1"/>
          <p:nvPr/>
        </p:nvSpPr>
        <p:spPr>
          <a:xfrm>
            <a:off x="2015521" y="5460354"/>
            <a:ext cx="23774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Image-1: No expression</a:t>
            </a:r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6AE47EAC-29F2-762A-053B-6CFBB6B23F5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480049" y="1160717"/>
            <a:ext cx="3792964" cy="4195066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D9050CA4-B5F1-E6E7-9080-0811406C5FA6}"/>
              </a:ext>
            </a:extLst>
          </p:cNvPr>
          <p:cNvSpPr txBox="1"/>
          <p:nvPr/>
        </p:nvSpPr>
        <p:spPr>
          <a:xfrm>
            <a:off x="7187811" y="5454382"/>
            <a:ext cx="2988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Image-2: Low expression</a:t>
            </a:r>
          </a:p>
        </p:txBody>
      </p:sp>
    </p:spTree>
    <p:extLst>
      <p:ext uri="{BB962C8B-B14F-4D97-AF65-F5344CB8AC3E}">
        <p14:creationId xmlns:p14="http://schemas.microsoft.com/office/powerpoint/2010/main" val="10976418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5EFF703E-7620-CBF8-225C-DAA6EDCCE54B}"/>
              </a:ext>
            </a:extLst>
          </p:cNvPr>
          <p:cNvSpPr txBox="1"/>
          <p:nvPr/>
        </p:nvSpPr>
        <p:spPr>
          <a:xfrm>
            <a:off x="4453128" y="146304"/>
            <a:ext cx="43616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Proximal colon cancer samples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DF3226A8-F2B8-839A-BEA7-F9CEF1D0E90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01457" y="1129272"/>
            <a:ext cx="3792964" cy="4195066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7C09C9E7-B51A-5ABE-EB0A-D571A687747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657859" y="1129272"/>
            <a:ext cx="3792964" cy="4195066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5997AB76-928D-D551-5DEA-9E1833E8B463}"/>
              </a:ext>
            </a:extLst>
          </p:cNvPr>
          <p:cNvSpPr txBox="1"/>
          <p:nvPr/>
        </p:nvSpPr>
        <p:spPr>
          <a:xfrm>
            <a:off x="1454776" y="5544062"/>
            <a:ext cx="34863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Image-3: Intermediate expression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2218E1AE-FDA0-97EC-FAAD-AC0BE440C2C2}"/>
              </a:ext>
            </a:extLst>
          </p:cNvPr>
          <p:cNvSpPr txBox="1"/>
          <p:nvPr/>
        </p:nvSpPr>
        <p:spPr>
          <a:xfrm>
            <a:off x="6964498" y="5467862"/>
            <a:ext cx="34863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Image-4: High expression</a:t>
            </a:r>
          </a:p>
        </p:txBody>
      </p:sp>
    </p:spTree>
    <p:extLst>
      <p:ext uri="{BB962C8B-B14F-4D97-AF65-F5344CB8AC3E}">
        <p14:creationId xmlns:p14="http://schemas.microsoft.com/office/powerpoint/2010/main" val="373571209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9443E444-88A2-043B-6274-CAFE1BD2309D}"/>
              </a:ext>
            </a:extLst>
          </p:cNvPr>
          <p:cNvSpPr txBox="1"/>
          <p:nvPr/>
        </p:nvSpPr>
        <p:spPr>
          <a:xfrm>
            <a:off x="4453128" y="146304"/>
            <a:ext cx="43616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Distal colon cancer samples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FF2F9440-8C1C-65E0-F583-63D7BE67DD70}"/>
              </a:ext>
            </a:extLst>
          </p:cNvPr>
          <p:cNvSpPr txBox="1"/>
          <p:nvPr/>
        </p:nvSpPr>
        <p:spPr>
          <a:xfrm>
            <a:off x="1799049" y="5268330"/>
            <a:ext cx="23774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Image-1: No expression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859BF49A-6A3A-AE93-7B5A-8F9B45C07BC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56650" y="932501"/>
            <a:ext cx="3790254" cy="4192069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C26937ED-09F8-BB8A-9D92-53DDC04B7ADC}"/>
              </a:ext>
            </a:extLst>
          </p:cNvPr>
          <p:cNvSpPr txBox="1"/>
          <p:nvPr/>
        </p:nvSpPr>
        <p:spPr>
          <a:xfrm>
            <a:off x="7187811" y="5454382"/>
            <a:ext cx="29886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Image-2: Low expression</a:t>
            </a: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F587808E-2ADC-B4B1-5F81-2B59F7564DD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787018" y="932500"/>
            <a:ext cx="3790254" cy="419206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2253119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4EC9DFEB-E6EB-F21C-7F57-74055F41D162}"/>
              </a:ext>
            </a:extLst>
          </p:cNvPr>
          <p:cNvSpPr txBox="1"/>
          <p:nvPr/>
        </p:nvSpPr>
        <p:spPr>
          <a:xfrm>
            <a:off x="4453128" y="146304"/>
            <a:ext cx="43616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Distal colon cancer samples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C2781F2B-F53C-BEF7-6F69-525988A41CA5}"/>
              </a:ext>
            </a:extLst>
          </p:cNvPr>
          <p:cNvSpPr txBox="1"/>
          <p:nvPr/>
        </p:nvSpPr>
        <p:spPr>
          <a:xfrm>
            <a:off x="1454776" y="5544062"/>
            <a:ext cx="34863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Image-3: Intermediate expression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637550A5-0F6C-990C-A5BB-EDEEDB5660AF}"/>
              </a:ext>
            </a:extLst>
          </p:cNvPr>
          <p:cNvSpPr txBox="1"/>
          <p:nvPr/>
        </p:nvSpPr>
        <p:spPr>
          <a:xfrm>
            <a:off x="7071653" y="5544062"/>
            <a:ext cx="34863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Image-4: High expression</a:t>
            </a:r>
          </a:p>
        </p:txBody>
      </p:sp>
      <p:pic>
        <p:nvPicPr>
          <p:cNvPr id="12" name="Picture 11">
            <a:extLst>
              <a:ext uri="{FF2B5EF4-FFF2-40B4-BE49-F238E27FC236}">
                <a16:creationId xmlns:a16="http://schemas.microsoft.com/office/drawing/2014/main" id="{53E5C944-C60C-67AD-BD87-24B1B4048F9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54776" y="1023940"/>
            <a:ext cx="3790254" cy="4192069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6690D765-FAFF-4760-F8D5-FADE7979FF3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522911" y="1023940"/>
            <a:ext cx="3790254" cy="419206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3097709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6</TotalTime>
  <Words>48</Words>
  <Application>Microsoft Office PowerPoint</Application>
  <PresentationFormat>Widescreen</PresentationFormat>
  <Paragraphs>12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hilpa Bisht</dc:creator>
  <cp:lastModifiedBy>Shilpa Bisht</cp:lastModifiedBy>
  <cp:revision>6</cp:revision>
  <dcterms:created xsi:type="dcterms:W3CDTF">2023-10-13T19:47:44Z</dcterms:created>
  <dcterms:modified xsi:type="dcterms:W3CDTF">2023-10-13T20:34:16Z</dcterms:modified>
</cp:coreProperties>
</file>